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49" autoAdjust="0"/>
    <p:restoredTop sz="94660"/>
  </p:normalViewPr>
  <p:slideViewPr>
    <p:cSldViewPr snapToGrid="0">
      <p:cViewPr varScale="1">
        <p:scale>
          <a:sx n="64" d="100"/>
          <a:sy n="64" d="100"/>
        </p:scale>
        <p:origin x="48" y="1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0EE64E-E46F-72E2-B652-6027A8B833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EE2F2C2-D2A1-007E-2589-C44463BA6A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AEDC7C-69C4-07A1-AB08-5CDF99B02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E417BC-FBC8-A1BD-F99F-7D38ADA7B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67D47E-3604-30F5-8207-7E797DE4B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7077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9C20D7-B772-3874-CC8E-5A543CFF5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AA0884-09AC-0042-B50E-F791667688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2C86FD-B8C6-03BC-D468-46C1F3709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7E259D-A4AD-7037-09FD-4B5BE90B6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EB5AEE-0785-BC7B-3E6B-8B441BC01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534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5950633-B685-0900-D674-D7A6AFB1A0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4C85C4A-D5DC-8AB0-77DF-D0F925DF2C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D1C542-6288-2478-62E9-26F472C68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3C976-2821-6A48-009F-4629AC928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4B5ABA-3F5A-B905-EFBF-6101FAFB8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6055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62945E-B37C-4E24-6759-7ED589C8B2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7B68D6-B6D2-739C-3E5F-CEA4EB398F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0A9BC2-D62A-DDAB-E1DC-6744C51EA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35E091-DBC4-B14D-69C1-09A2DE300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09D474-862E-C5A7-5CA2-1829431D4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907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E49AA0-D759-072D-FB84-F19B732640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72D2A02-6BFB-4687-861D-A11DBE2B90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76FE1D-44E6-B83A-2884-8FED61656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DA3A11-4DB1-44EF-6753-CB07F6545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2A714D-9530-771D-2733-6D2381FAD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193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F77302-F859-AEEC-E01A-EC50790DE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6BE3EEF-EF76-DAD8-CFA4-986601E126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E2BA781-9D13-441B-7DB9-D45C1E87BC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9B23E0-C0E9-52F6-86B1-59CEC8E81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B32E9A9-ACE9-12A6-5946-0DBB3D83F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19AC86-2183-F493-2897-9023E2853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070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3BA3C5-7665-EB86-4D9C-CCB2410F5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E108215-781A-D484-12C0-F266506C7D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FEC3B2-E6F0-3F0D-B412-2C6C4C1A1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7DCDE4-1650-BA9B-4957-D506BC4F89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6DC794E-B620-7715-864E-91698BBC3C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D285C06-DB4B-1294-C7B0-E36E8FD2D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7D3B2E0-5FB2-F6FF-FF99-CE3F5A7B3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E3365C7-6E90-51B2-B0AC-BBD256448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4631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5A82B2-0D5B-59DE-8FAA-49F237230C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09262EB-A282-90C4-AD4A-BAA638CE2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9AEDE86-40FC-F4F8-6E00-D4F21904A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8F8308-B60C-9CB9-32DB-F8E009299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730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543EBDC-7FBD-30D7-540C-E3288AA89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FEA5652-C3F4-E682-6D8D-3A5E29178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88389B0-BE2F-1E1E-4F42-6B663090F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9806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7092CB-44F0-B1C6-76ED-BC652BC6A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27BF75F-4C34-C353-E1F7-8B381B7B3B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DF0F29A-BC35-ED64-F763-4D23BC98CC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8C388AE-0579-6AF8-AB52-E96195D94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FBFADB-D75A-3661-B742-EC13966F5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1F9EAF-0AE1-787F-40D2-5069CA98C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662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DAF4B8-1FC7-7344-0ABE-4BE6510BA9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CF55970-75B5-074E-CE37-BC9954CDE8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45B3825-19A4-BD57-E417-0EEED4BD72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19473C7-A2D4-D3D9-84CB-CF62B7806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D8C3CC-96E8-EA73-FB52-C7DAFF852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49B4F65-9A01-3882-8CBB-19F2C51B8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472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293B5BF-6D90-9F56-6CA0-8F5C82CC91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4C7E49-D662-4421-4E19-0C8A6D899D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9CE8F0-CEC8-C2BA-92AA-BE2FA23773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B2892-C134-46A9-B1EE-F148CE223332}" type="datetimeFigureOut">
              <a:rPr kumimoji="1" lang="ja-JP" altLang="en-US" smtClean="0"/>
              <a:t>2023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16D40D-F6A2-FE2D-42E1-FD1ED2403C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9E88C6-8763-E48C-4839-E46430243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9566C-F9DC-4B17-BBF2-3222F9AD30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2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C8EF377-DDAB-28DF-7565-07951E72F01B}"/>
              </a:ext>
            </a:extLst>
          </p:cNvPr>
          <p:cNvSpPr txBox="1"/>
          <p:nvPr/>
        </p:nvSpPr>
        <p:spPr>
          <a:xfrm>
            <a:off x="128476" y="0"/>
            <a:ext cx="7555213" cy="6463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1: Details of progressive aortic event </a:t>
            </a: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FADF71D0-0A8D-96ED-3FA3-6BD71814DF15}"/>
              </a:ext>
            </a:extLst>
          </p:cNvPr>
          <p:cNvGrpSpPr/>
          <p:nvPr/>
        </p:nvGrpSpPr>
        <p:grpSpPr>
          <a:xfrm>
            <a:off x="146830" y="3776618"/>
            <a:ext cx="3317336" cy="2787743"/>
            <a:chOff x="174708" y="545580"/>
            <a:chExt cx="3317336" cy="2787743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7771131A-EA1A-4E3B-04F5-D31DFC1C3E39}"/>
                </a:ext>
              </a:extLst>
            </p:cNvPr>
            <p:cNvSpPr/>
            <p:nvPr/>
          </p:nvSpPr>
          <p:spPr>
            <a:xfrm>
              <a:off x="174708" y="545580"/>
              <a:ext cx="3317336" cy="27877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FC391B0-3C9A-84BC-8CC9-B153277D68C8}"/>
                </a:ext>
              </a:extLst>
            </p:cNvPr>
            <p:cNvSpPr txBox="1"/>
            <p:nvPr/>
          </p:nvSpPr>
          <p:spPr>
            <a:xfrm>
              <a:off x="316221" y="599914"/>
              <a:ext cx="3037440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largement of the aortic dimension, n=10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CAF4A5D-92E2-FC22-2FEB-E17F20C5FD84}"/>
                </a:ext>
              </a:extLst>
            </p:cNvPr>
            <p:cNvSpPr txBox="1"/>
            <p:nvPr/>
          </p:nvSpPr>
          <p:spPr>
            <a:xfrm>
              <a:off x="316222" y="1237835"/>
              <a:ext cx="160916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ical intervention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7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AD77CC2-2584-23CB-D860-BB35F3C525AF}"/>
                </a:ext>
              </a:extLst>
            </p:cNvPr>
            <p:cNvSpPr txBox="1"/>
            <p:nvPr/>
          </p:nvSpPr>
          <p:spPr>
            <a:xfrm>
              <a:off x="2173364" y="1243154"/>
              <a:ext cx="118437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rvative therap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FB7DD55-F3F0-F9EF-1598-A3313950A3B9}"/>
                </a:ext>
              </a:extLst>
            </p:cNvPr>
            <p:cNvSpPr txBox="1"/>
            <p:nvPr/>
          </p:nvSpPr>
          <p:spPr>
            <a:xfrm>
              <a:off x="290263" y="2281699"/>
              <a:ext cx="1300469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EVAR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4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0FC4CB8-3E0D-3442-43D9-8E9928A6CD7D}"/>
                </a:ext>
              </a:extLst>
            </p:cNvPr>
            <p:cNvSpPr txBox="1"/>
            <p:nvPr/>
          </p:nvSpPr>
          <p:spPr>
            <a:xfrm>
              <a:off x="1695942" y="2925448"/>
              <a:ext cx="1668275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E721D93E-B577-A34B-6976-C63FFDD392ED}"/>
                </a:ext>
              </a:extLst>
            </p:cNvPr>
            <p:cNvCxnSpPr>
              <a:cxnSpLocks/>
              <a:stCxn id="7" idx="2"/>
              <a:endCxn id="8" idx="0"/>
            </p:cNvCxnSpPr>
            <p:nvPr/>
          </p:nvCxnSpPr>
          <p:spPr>
            <a:xfrm flipH="1">
              <a:off x="1120803" y="1123134"/>
              <a:ext cx="714138" cy="11470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AC15852A-672A-A4F6-0CE0-31049B3EFABB}"/>
                </a:ext>
              </a:extLst>
            </p:cNvPr>
            <p:cNvCxnSpPr>
              <a:cxnSpLocks/>
              <a:stCxn id="7" idx="2"/>
              <a:endCxn id="9" idx="0"/>
            </p:cNvCxnSpPr>
            <p:nvPr/>
          </p:nvCxnSpPr>
          <p:spPr>
            <a:xfrm>
              <a:off x="1834941" y="1123134"/>
              <a:ext cx="930609" cy="1200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654DEE9F-B858-EDBD-7C2F-1563B73AF737}"/>
                </a:ext>
              </a:extLst>
            </p:cNvPr>
            <p:cNvCxnSpPr>
              <a:cxnSpLocks/>
              <a:stCxn id="8" idx="2"/>
              <a:endCxn id="10" idx="0"/>
            </p:cNvCxnSpPr>
            <p:nvPr/>
          </p:nvCxnSpPr>
          <p:spPr>
            <a:xfrm flipH="1">
              <a:off x="940498" y="1761055"/>
              <a:ext cx="180305" cy="5206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0E2BC7E7-EB9D-656B-B9CF-E423E0B44CB8}"/>
                </a:ext>
              </a:extLst>
            </p:cNvPr>
            <p:cNvCxnSpPr>
              <a:cxnSpLocks/>
              <a:stCxn id="8" idx="2"/>
              <a:endCxn id="19" idx="0"/>
            </p:cNvCxnSpPr>
            <p:nvPr/>
          </p:nvCxnSpPr>
          <p:spPr>
            <a:xfrm>
              <a:off x="1120803" y="1761055"/>
              <a:ext cx="1407388" cy="5375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50373B6B-0154-A301-BEFB-9ACA001BFB97}"/>
                </a:ext>
              </a:extLst>
            </p:cNvPr>
            <p:cNvCxnSpPr>
              <a:cxnSpLocks/>
              <a:stCxn id="9" idx="2"/>
              <a:endCxn id="21" idx="0"/>
            </p:cNvCxnSpPr>
            <p:nvPr/>
          </p:nvCxnSpPr>
          <p:spPr>
            <a:xfrm flipH="1">
              <a:off x="2763288" y="1766374"/>
              <a:ext cx="2262" cy="6588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98569F5C-C311-5E38-12A0-3DECA7F85D44}"/>
                </a:ext>
              </a:extLst>
            </p:cNvPr>
            <p:cNvCxnSpPr>
              <a:cxnSpLocks/>
              <a:stCxn id="10" idx="2"/>
              <a:endCxn id="20" idx="0"/>
            </p:cNvCxnSpPr>
            <p:nvPr/>
          </p:nvCxnSpPr>
          <p:spPr>
            <a:xfrm flipH="1">
              <a:off x="938716" y="2804919"/>
              <a:ext cx="1782" cy="11941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7ADF88AC-6960-D1B0-A4E6-974E01A33E13}"/>
                </a:ext>
              </a:extLst>
            </p:cNvPr>
            <p:cNvCxnSpPr>
              <a:cxnSpLocks/>
              <a:stCxn id="19" idx="2"/>
              <a:endCxn id="11" idx="0"/>
            </p:cNvCxnSpPr>
            <p:nvPr/>
          </p:nvCxnSpPr>
          <p:spPr>
            <a:xfrm>
              <a:off x="2528191" y="2821791"/>
              <a:ext cx="1889" cy="10365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F9A940F-29ED-792C-4EBF-5D08DC5E8F54}"/>
                </a:ext>
              </a:extLst>
            </p:cNvPr>
            <p:cNvSpPr txBox="1"/>
            <p:nvPr/>
          </p:nvSpPr>
          <p:spPr>
            <a:xfrm>
              <a:off x="1702721" y="2298571"/>
              <a:ext cx="1650939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horacotom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4EA38788-7689-F18C-41AD-58ABBBA118F3}"/>
                </a:ext>
              </a:extLst>
            </p:cNvPr>
            <p:cNvSpPr txBox="1"/>
            <p:nvPr/>
          </p:nvSpPr>
          <p:spPr>
            <a:xfrm>
              <a:off x="288481" y="2924337"/>
              <a:ext cx="130046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EBE0938-4965-03EE-3390-B10FC8841607}"/>
                </a:ext>
              </a:extLst>
            </p:cNvPr>
            <p:cNvSpPr txBox="1"/>
            <p:nvPr/>
          </p:nvSpPr>
          <p:spPr>
            <a:xfrm>
              <a:off x="2169288" y="1832260"/>
              <a:ext cx="1188000" cy="28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E026C620-F769-95FF-6446-80025B81C47B}"/>
              </a:ext>
            </a:extLst>
          </p:cNvPr>
          <p:cNvGrpSpPr/>
          <p:nvPr/>
        </p:nvGrpSpPr>
        <p:grpSpPr>
          <a:xfrm>
            <a:off x="10319155" y="3778214"/>
            <a:ext cx="1755957" cy="2780170"/>
            <a:chOff x="10217971" y="3778214"/>
            <a:chExt cx="1857141" cy="2780170"/>
          </a:xfrm>
        </p:grpSpPr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C3B1F685-C60F-2B4A-C559-CFA5C94DF8C7}"/>
                </a:ext>
              </a:extLst>
            </p:cNvPr>
            <p:cNvSpPr/>
            <p:nvPr/>
          </p:nvSpPr>
          <p:spPr>
            <a:xfrm>
              <a:off x="10217971" y="3778214"/>
              <a:ext cx="1857141" cy="27801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D1ECB8C7-5FD7-DA86-D6BF-EF381CAF693A}"/>
                </a:ext>
              </a:extLst>
            </p:cNvPr>
            <p:cNvSpPr txBox="1"/>
            <p:nvPr/>
          </p:nvSpPr>
          <p:spPr>
            <a:xfrm>
              <a:off x="10264462" y="3830952"/>
              <a:ext cx="1734040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urrence of dissection, 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A5CB959B-53AB-24D9-230F-C66D370C299A}"/>
                </a:ext>
              </a:extLst>
            </p:cNvPr>
            <p:cNvSpPr txBox="1"/>
            <p:nvPr/>
          </p:nvSpPr>
          <p:spPr>
            <a:xfrm>
              <a:off x="10262275" y="4870411"/>
              <a:ext cx="1734040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rvative therap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327C76BA-B11A-BE58-E610-A2D54D342F7A}"/>
                </a:ext>
              </a:extLst>
            </p:cNvPr>
            <p:cNvCxnSpPr>
              <a:cxnSpLocks/>
              <a:stCxn id="23" idx="2"/>
              <a:endCxn id="24" idx="0"/>
            </p:cNvCxnSpPr>
            <p:nvPr/>
          </p:nvCxnSpPr>
          <p:spPr>
            <a:xfrm flipH="1">
              <a:off x="11129295" y="4354172"/>
              <a:ext cx="2187" cy="5162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E9620BD0-76FE-643E-F1BB-DDB9C1845620}"/>
                </a:ext>
              </a:extLst>
            </p:cNvPr>
            <p:cNvCxnSpPr>
              <a:cxnSpLocks/>
              <a:stCxn id="24" idx="2"/>
              <a:endCxn id="27" idx="0"/>
            </p:cNvCxnSpPr>
            <p:nvPr/>
          </p:nvCxnSpPr>
          <p:spPr>
            <a:xfrm flipH="1">
              <a:off x="11128234" y="5393631"/>
              <a:ext cx="1061" cy="7557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60D50F1-337F-AD15-ACC0-5D39E76BF196}"/>
                </a:ext>
              </a:extLst>
            </p:cNvPr>
            <p:cNvSpPr txBox="1"/>
            <p:nvPr/>
          </p:nvSpPr>
          <p:spPr>
            <a:xfrm>
              <a:off x="10274586" y="6149395"/>
              <a:ext cx="1707295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A2C61E86-E0F9-C5C6-808F-4FE7ACDCCFE1}"/>
              </a:ext>
            </a:extLst>
          </p:cNvPr>
          <p:cNvGrpSpPr/>
          <p:nvPr/>
        </p:nvGrpSpPr>
        <p:grpSpPr>
          <a:xfrm>
            <a:off x="3501765" y="3770641"/>
            <a:ext cx="3317336" cy="2787743"/>
            <a:chOff x="3672523" y="539603"/>
            <a:chExt cx="3317336" cy="2787743"/>
          </a:xfrm>
        </p:grpSpPr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97FBC9FE-1DDD-9E1C-C332-EB34BC7CD930}"/>
                </a:ext>
              </a:extLst>
            </p:cNvPr>
            <p:cNvSpPr/>
            <p:nvPr/>
          </p:nvSpPr>
          <p:spPr>
            <a:xfrm>
              <a:off x="3672523" y="539603"/>
              <a:ext cx="3317336" cy="27877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87A65D1-22FB-9171-28ED-092EADF67267}"/>
                </a:ext>
              </a:extLst>
            </p:cNvPr>
            <p:cNvSpPr txBox="1"/>
            <p:nvPr/>
          </p:nvSpPr>
          <p:spPr>
            <a:xfrm>
              <a:off x="3814036" y="593937"/>
              <a:ext cx="3037440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rly expansion, n=4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68B2762-7A10-372C-6913-A127A678FDE6}"/>
                </a:ext>
              </a:extLst>
            </p:cNvPr>
            <p:cNvSpPr txBox="1"/>
            <p:nvPr/>
          </p:nvSpPr>
          <p:spPr>
            <a:xfrm>
              <a:off x="3814037" y="1231858"/>
              <a:ext cx="160916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ical intervention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3B831BB-E6D8-13E6-AE52-BE3BA2D6AEC4}"/>
                </a:ext>
              </a:extLst>
            </p:cNvPr>
            <p:cNvSpPr txBox="1"/>
            <p:nvPr/>
          </p:nvSpPr>
          <p:spPr>
            <a:xfrm>
              <a:off x="5671179" y="1237177"/>
              <a:ext cx="118437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rvative therap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B723C76-460C-6FDD-22B4-DFBF48428913}"/>
                </a:ext>
              </a:extLst>
            </p:cNvPr>
            <p:cNvSpPr txBox="1"/>
            <p:nvPr/>
          </p:nvSpPr>
          <p:spPr>
            <a:xfrm>
              <a:off x="3788078" y="2275722"/>
              <a:ext cx="1300469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EVAR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89872348-4A65-75F2-ABAA-5B3235E97620}"/>
                </a:ext>
              </a:extLst>
            </p:cNvPr>
            <p:cNvSpPr txBox="1"/>
            <p:nvPr/>
          </p:nvSpPr>
          <p:spPr>
            <a:xfrm>
              <a:off x="5200537" y="2918360"/>
              <a:ext cx="1668275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5F0A0910-A1FE-BC33-D537-8282C7098181}"/>
                </a:ext>
              </a:extLst>
            </p:cNvPr>
            <p:cNvCxnSpPr>
              <a:cxnSpLocks/>
              <a:stCxn id="30" idx="2"/>
              <a:endCxn id="31" idx="0"/>
            </p:cNvCxnSpPr>
            <p:nvPr/>
          </p:nvCxnSpPr>
          <p:spPr>
            <a:xfrm flipH="1">
              <a:off x="4618618" y="901714"/>
              <a:ext cx="714138" cy="3301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519DB3B7-98ED-AB24-6B1F-A7B5E12E287F}"/>
                </a:ext>
              </a:extLst>
            </p:cNvPr>
            <p:cNvCxnSpPr>
              <a:cxnSpLocks/>
              <a:stCxn id="30" idx="2"/>
              <a:endCxn id="32" idx="0"/>
            </p:cNvCxnSpPr>
            <p:nvPr/>
          </p:nvCxnSpPr>
          <p:spPr>
            <a:xfrm>
              <a:off x="5332756" y="901714"/>
              <a:ext cx="930609" cy="3354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879B359F-A5D0-2423-3986-750CB4E45DAA}"/>
                </a:ext>
              </a:extLst>
            </p:cNvPr>
            <p:cNvCxnSpPr>
              <a:cxnSpLocks/>
              <a:stCxn id="31" idx="2"/>
              <a:endCxn id="33" idx="0"/>
            </p:cNvCxnSpPr>
            <p:nvPr/>
          </p:nvCxnSpPr>
          <p:spPr>
            <a:xfrm flipH="1">
              <a:off x="4438313" y="1755078"/>
              <a:ext cx="180305" cy="5206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050CA355-32C0-18CF-8264-A76A35C50C09}"/>
                </a:ext>
              </a:extLst>
            </p:cNvPr>
            <p:cNvCxnSpPr>
              <a:cxnSpLocks/>
              <a:stCxn id="31" idx="2"/>
              <a:endCxn id="42" idx="0"/>
            </p:cNvCxnSpPr>
            <p:nvPr/>
          </p:nvCxnSpPr>
          <p:spPr>
            <a:xfrm>
              <a:off x="4618618" y="1755078"/>
              <a:ext cx="1407388" cy="5375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10724C2C-979A-6619-8A7B-AB623CE49ACA}"/>
                </a:ext>
              </a:extLst>
            </p:cNvPr>
            <p:cNvCxnSpPr>
              <a:cxnSpLocks/>
              <a:stCxn id="32" idx="2"/>
              <a:endCxn id="44" idx="0"/>
            </p:cNvCxnSpPr>
            <p:nvPr/>
          </p:nvCxnSpPr>
          <p:spPr>
            <a:xfrm flipH="1">
              <a:off x="6261104" y="1760397"/>
              <a:ext cx="2261" cy="718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id="{51F5025F-3607-337F-D625-EEB2EF82488B}"/>
                </a:ext>
              </a:extLst>
            </p:cNvPr>
            <p:cNvCxnSpPr>
              <a:cxnSpLocks/>
              <a:stCxn id="33" idx="2"/>
              <a:endCxn id="43" idx="0"/>
            </p:cNvCxnSpPr>
            <p:nvPr/>
          </p:nvCxnSpPr>
          <p:spPr>
            <a:xfrm>
              <a:off x="4438313" y="2798942"/>
              <a:ext cx="0" cy="1194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C1C35270-F3B6-91A8-8413-8A4745844703}"/>
                </a:ext>
              </a:extLst>
            </p:cNvPr>
            <p:cNvCxnSpPr>
              <a:cxnSpLocks/>
              <a:stCxn id="42" idx="2"/>
              <a:endCxn id="34" idx="0"/>
            </p:cNvCxnSpPr>
            <p:nvPr/>
          </p:nvCxnSpPr>
          <p:spPr>
            <a:xfrm>
              <a:off x="6026006" y="2815814"/>
              <a:ext cx="8669" cy="1025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72137DB4-A99C-BB12-083E-0934FA4E4B0C}"/>
                </a:ext>
              </a:extLst>
            </p:cNvPr>
            <p:cNvSpPr txBox="1"/>
            <p:nvPr/>
          </p:nvSpPr>
          <p:spPr>
            <a:xfrm>
              <a:off x="5200536" y="2292594"/>
              <a:ext cx="1650939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horacotom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B3429F85-31F3-4511-606B-7C39B1E82C1C}"/>
                </a:ext>
              </a:extLst>
            </p:cNvPr>
            <p:cNvSpPr txBox="1"/>
            <p:nvPr/>
          </p:nvSpPr>
          <p:spPr>
            <a:xfrm>
              <a:off x="3788078" y="2918356"/>
              <a:ext cx="130046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0DC065A4-7DC7-7B2B-45AE-7075B08F0930}"/>
                </a:ext>
              </a:extLst>
            </p:cNvPr>
            <p:cNvSpPr txBox="1"/>
            <p:nvPr/>
          </p:nvSpPr>
          <p:spPr>
            <a:xfrm>
              <a:off x="5667104" y="1832261"/>
              <a:ext cx="1188000" cy="28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9B453C59-9C69-F9C1-18F8-87176CA0BBF7}"/>
              </a:ext>
            </a:extLst>
          </p:cNvPr>
          <p:cNvGrpSpPr/>
          <p:nvPr/>
        </p:nvGrpSpPr>
        <p:grpSpPr>
          <a:xfrm>
            <a:off x="6836393" y="3770641"/>
            <a:ext cx="3341249" cy="2787743"/>
            <a:chOff x="7116792" y="539603"/>
            <a:chExt cx="3317336" cy="2787743"/>
          </a:xfrm>
        </p:grpSpPr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65F224D6-9083-6B40-BD97-C52961384B03}"/>
                </a:ext>
              </a:extLst>
            </p:cNvPr>
            <p:cNvSpPr/>
            <p:nvPr/>
          </p:nvSpPr>
          <p:spPr>
            <a:xfrm>
              <a:off x="7116792" y="539603"/>
              <a:ext cx="3317336" cy="27877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11D20B27-73C0-4A10-05BF-CEBD4C735517}"/>
                </a:ext>
              </a:extLst>
            </p:cNvPr>
            <p:cNvSpPr txBox="1"/>
            <p:nvPr/>
          </p:nvSpPr>
          <p:spPr>
            <a:xfrm>
              <a:off x="7258305" y="593937"/>
              <a:ext cx="3037440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ortic rupture, n=7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3D7C5127-4989-0390-198E-6C9EEBF76341}"/>
                </a:ext>
              </a:extLst>
            </p:cNvPr>
            <p:cNvSpPr txBox="1"/>
            <p:nvPr/>
          </p:nvSpPr>
          <p:spPr>
            <a:xfrm>
              <a:off x="7258306" y="1231858"/>
              <a:ext cx="160916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ical intervention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4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69CBEA7B-84D3-15E9-D58A-E201F529BA10}"/>
                </a:ext>
              </a:extLst>
            </p:cNvPr>
            <p:cNvSpPr txBox="1"/>
            <p:nvPr/>
          </p:nvSpPr>
          <p:spPr>
            <a:xfrm>
              <a:off x="9115448" y="1237177"/>
              <a:ext cx="1184372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rvative therap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994B274E-80A0-023B-F198-F22EB8762A95}"/>
                </a:ext>
              </a:extLst>
            </p:cNvPr>
            <p:cNvSpPr txBox="1"/>
            <p:nvPr/>
          </p:nvSpPr>
          <p:spPr>
            <a:xfrm>
              <a:off x="7228750" y="2296821"/>
              <a:ext cx="1300469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EVAR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2CD03C32-7AA0-FE67-DA69-6DC7A85C2552}"/>
                </a:ext>
              </a:extLst>
            </p:cNvPr>
            <p:cNvSpPr txBox="1"/>
            <p:nvPr/>
          </p:nvSpPr>
          <p:spPr>
            <a:xfrm>
              <a:off x="8644806" y="2917691"/>
              <a:ext cx="1668275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矢印コネクタ 51">
              <a:extLst>
                <a:ext uri="{FF2B5EF4-FFF2-40B4-BE49-F238E27FC236}">
                  <a16:creationId xmlns:a16="http://schemas.microsoft.com/office/drawing/2014/main" id="{4B022B2C-2500-C58B-5862-7E829CFCA26C}"/>
                </a:ext>
              </a:extLst>
            </p:cNvPr>
            <p:cNvCxnSpPr>
              <a:cxnSpLocks/>
              <a:stCxn id="47" idx="2"/>
              <a:endCxn id="48" idx="0"/>
            </p:cNvCxnSpPr>
            <p:nvPr/>
          </p:nvCxnSpPr>
          <p:spPr>
            <a:xfrm flipH="1">
              <a:off x="8062887" y="901714"/>
              <a:ext cx="714138" cy="3301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矢印コネクタ 52">
              <a:extLst>
                <a:ext uri="{FF2B5EF4-FFF2-40B4-BE49-F238E27FC236}">
                  <a16:creationId xmlns:a16="http://schemas.microsoft.com/office/drawing/2014/main" id="{6FBC2BAC-373F-577A-772A-319B920D9BC8}"/>
                </a:ext>
              </a:extLst>
            </p:cNvPr>
            <p:cNvCxnSpPr>
              <a:cxnSpLocks/>
              <a:stCxn id="47" idx="2"/>
              <a:endCxn id="49" idx="0"/>
            </p:cNvCxnSpPr>
            <p:nvPr/>
          </p:nvCxnSpPr>
          <p:spPr>
            <a:xfrm>
              <a:off x="8777025" y="901714"/>
              <a:ext cx="930609" cy="3354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矢印コネクタ 53">
              <a:extLst>
                <a:ext uri="{FF2B5EF4-FFF2-40B4-BE49-F238E27FC236}">
                  <a16:creationId xmlns:a16="http://schemas.microsoft.com/office/drawing/2014/main" id="{76C1AD62-3C72-27E8-3259-EA30156C0E40}"/>
                </a:ext>
              </a:extLst>
            </p:cNvPr>
            <p:cNvCxnSpPr>
              <a:cxnSpLocks/>
              <a:stCxn id="48" idx="2"/>
              <a:endCxn id="50" idx="0"/>
            </p:cNvCxnSpPr>
            <p:nvPr/>
          </p:nvCxnSpPr>
          <p:spPr>
            <a:xfrm flipH="1">
              <a:off x="7878985" y="1755078"/>
              <a:ext cx="183902" cy="54174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>
              <a:extLst>
                <a:ext uri="{FF2B5EF4-FFF2-40B4-BE49-F238E27FC236}">
                  <a16:creationId xmlns:a16="http://schemas.microsoft.com/office/drawing/2014/main" id="{67486D38-E209-5AD3-32C5-E667E2CEF771}"/>
                </a:ext>
              </a:extLst>
            </p:cNvPr>
            <p:cNvCxnSpPr>
              <a:cxnSpLocks/>
              <a:stCxn id="48" idx="2"/>
              <a:endCxn id="59" idx="0"/>
            </p:cNvCxnSpPr>
            <p:nvPr/>
          </p:nvCxnSpPr>
          <p:spPr>
            <a:xfrm>
              <a:off x="8062887" y="1755078"/>
              <a:ext cx="1417213" cy="5464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id="{0968909C-76E5-AD71-72D9-68FDBEF63D6D}"/>
                </a:ext>
              </a:extLst>
            </p:cNvPr>
            <p:cNvCxnSpPr>
              <a:cxnSpLocks/>
              <a:stCxn id="49" idx="2"/>
              <a:endCxn id="61" idx="0"/>
            </p:cNvCxnSpPr>
            <p:nvPr/>
          </p:nvCxnSpPr>
          <p:spPr>
            <a:xfrm flipH="1">
              <a:off x="9705372" y="1760397"/>
              <a:ext cx="2262" cy="7053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矢印コネクタ 56">
              <a:extLst>
                <a:ext uri="{FF2B5EF4-FFF2-40B4-BE49-F238E27FC236}">
                  <a16:creationId xmlns:a16="http://schemas.microsoft.com/office/drawing/2014/main" id="{CDC26577-E18C-9957-0D4A-715ABA6B3849}"/>
                </a:ext>
              </a:extLst>
            </p:cNvPr>
            <p:cNvCxnSpPr>
              <a:cxnSpLocks/>
              <a:stCxn id="50" idx="2"/>
              <a:endCxn id="60" idx="0"/>
            </p:cNvCxnSpPr>
            <p:nvPr/>
          </p:nvCxnSpPr>
          <p:spPr>
            <a:xfrm>
              <a:off x="7878985" y="2820041"/>
              <a:ext cx="1815" cy="9831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矢印コネクタ 57">
              <a:extLst>
                <a:ext uri="{FF2B5EF4-FFF2-40B4-BE49-F238E27FC236}">
                  <a16:creationId xmlns:a16="http://schemas.microsoft.com/office/drawing/2014/main" id="{E319A97A-EFF5-52AC-B9A8-C39BAE1BFBA9}"/>
                </a:ext>
              </a:extLst>
            </p:cNvPr>
            <p:cNvCxnSpPr>
              <a:cxnSpLocks/>
              <a:stCxn id="59" idx="2"/>
              <a:endCxn id="51" idx="0"/>
            </p:cNvCxnSpPr>
            <p:nvPr/>
          </p:nvCxnSpPr>
          <p:spPr>
            <a:xfrm flipH="1">
              <a:off x="9478944" y="2824763"/>
              <a:ext cx="1156" cy="9292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BE4FF99F-1604-72D2-DBB0-E7587477B6E5}"/>
                </a:ext>
              </a:extLst>
            </p:cNvPr>
            <p:cNvSpPr txBox="1"/>
            <p:nvPr/>
          </p:nvSpPr>
          <p:spPr>
            <a:xfrm>
              <a:off x="8659834" y="2301543"/>
              <a:ext cx="1640531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horacotom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C9AC5CA4-33D0-5136-5AFD-FCFD75D03B76}"/>
                </a:ext>
              </a:extLst>
            </p:cNvPr>
            <p:cNvSpPr txBox="1"/>
            <p:nvPr/>
          </p:nvSpPr>
          <p:spPr>
            <a:xfrm>
              <a:off x="7230565" y="2918358"/>
              <a:ext cx="130046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A6A515AD-D04E-E4C5-CED6-8077DE5721FF}"/>
                </a:ext>
              </a:extLst>
            </p:cNvPr>
            <p:cNvSpPr txBox="1"/>
            <p:nvPr/>
          </p:nvSpPr>
          <p:spPr>
            <a:xfrm>
              <a:off x="9111372" y="1830927"/>
              <a:ext cx="1188000" cy="28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8C1341C2-93B5-7CC1-1A3F-6F88B6976065}"/>
              </a:ext>
            </a:extLst>
          </p:cNvPr>
          <p:cNvGrpSpPr/>
          <p:nvPr/>
        </p:nvGrpSpPr>
        <p:grpSpPr>
          <a:xfrm>
            <a:off x="2982353" y="433199"/>
            <a:ext cx="6215884" cy="2787743"/>
            <a:chOff x="500771" y="3783827"/>
            <a:chExt cx="3317336" cy="2787743"/>
          </a:xfrm>
        </p:grpSpPr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9C7BB107-C2C1-66AA-B024-BCF610DBB3D1}"/>
                </a:ext>
              </a:extLst>
            </p:cNvPr>
            <p:cNvSpPr/>
            <p:nvPr/>
          </p:nvSpPr>
          <p:spPr>
            <a:xfrm>
              <a:off x="500771" y="3783827"/>
              <a:ext cx="3317336" cy="27877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A7D989A5-8CD6-1CCC-3303-AD51461633D3}"/>
                </a:ext>
              </a:extLst>
            </p:cNvPr>
            <p:cNvSpPr txBox="1"/>
            <p:nvPr/>
          </p:nvSpPr>
          <p:spPr>
            <a:xfrm>
              <a:off x="642284" y="3838161"/>
              <a:ext cx="3037440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gressive aortic events, n=24</a:t>
              </a: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A898131E-99EE-B4E3-A3B8-0B4B669E51B1}"/>
                </a:ext>
              </a:extLst>
            </p:cNvPr>
            <p:cNvSpPr txBox="1"/>
            <p:nvPr/>
          </p:nvSpPr>
          <p:spPr>
            <a:xfrm>
              <a:off x="642285" y="4431404"/>
              <a:ext cx="1609162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ical intervention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4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50078EC-56D9-2D72-566F-E6934FA3AB49}"/>
                </a:ext>
              </a:extLst>
            </p:cNvPr>
            <p:cNvSpPr txBox="1"/>
            <p:nvPr/>
          </p:nvSpPr>
          <p:spPr>
            <a:xfrm>
              <a:off x="2431752" y="4436723"/>
              <a:ext cx="1252047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rvative therap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E5B83CF9-F536-DE0D-60B7-C26F77D0BF17}"/>
                </a:ext>
              </a:extLst>
            </p:cNvPr>
            <p:cNvSpPr txBox="1"/>
            <p:nvPr/>
          </p:nvSpPr>
          <p:spPr>
            <a:xfrm>
              <a:off x="616326" y="5614642"/>
              <a:ext cx="130046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EVAR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8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E56C8429-612E-456A-2E95-91DB35BC6081}"/>
                </a:ext>
              </a:extLst>
            </p:cNvPr>
            <p:cNvSpPr txBox="1"/>
            <p:nvPr/>
          </p:nvSpPr>
          <p:spPr>
            <a:xfrm>
              <a:off x="2020115" y="6162582"/>
              <a:ext cx="1668275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9" name="直線矢印コネクタ 68">
              <a:extLst>
                <a:ext uri="{FF2B5EF4-FFF2-40B4-BE49-F238E27FC236}">
                  <a16:creationId xmlns:a16="http://schemas.microsoft.com/office/drawing/2014/main" id="{D309D62D-373A-B663-8992-0D8227075917}"/>
                </a:ext>
              </a:extLst>
            </p:cNvPr>
            <p:cNvCxnSpPr>
              <a:cxnSpLocks/>
              <a:stCxn id="64" idx="2"/>
              <a:endCxn id="65" idx="0"/>
            </p:cNvCxnSpPr>
            <p:nvPr/>
          </p:nvCxnSpPr>
          <p:spPr>
            <a:xfrm flipH="1">
              <a:off x="1446866" y="4145938"/>
              <a:ext cx="714138" cy="2854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矢印コネクタ 69">
              <a:extLst>
                <a:ext uri="{FF2B5EF4-FFF2-40B4-BE49-F238E27FC236}">
                  <a16:creationId xmlns:a16="http://schemas.microsoft.com/office/drawing/2014/main" id="{9C5B3DD3-B484-F0C7-3810-246D1C704904}"/>
                </a:ext>
              </a:extLst>
            </p:cNvPr>
            <p:cNvCxnSpPr>
              <a:cxnSpLocks/>
              <a:stCxn id="64" idx="2"/>
              <a:endCxn id="66" idx="0"/>
            </p:cNvCxnSpPr>
            <p:nvPr/>
          </p:nvCxnSpPr>
          <p:spPr>
            <a:xfrm>
              <a:off x="2161004" y="4145938"/>
              <a:ext cx="896772" cy="29078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矢印コネクタ 70">
              <a:extLst>
                <a:ext uri="{FF2B5EF4-FFF2-40B4-BE49-F238E27FC236}">
                  <a16:creationId xmlns:a16="http://schemas.microsoft.com/office/drawing/2014/main" id="{B990202E-3C58-B084-4F37-6F9D86470413}"/>
                </a:ext>
              </a:extLst>
            </p:cNvPr>
            <p:cNvCxnSpPr>
              <a:cxnSpLocks/>
              <a:stCxn id="65" idx="2"/>
              <a:endCxn id="67" idx="0"/>
            </p:cNvCxnSpPr>
            <p:nvPr/>
          </p:nvCxnSpPr>
          <p:spPr>
            <a:xfrm flipH="1">
              <a:off x="1266560" y="4739181"/>
              <a:ext cx="180306" cy="87546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矢印コネクタ 71">
              <a:extLst>
                <a:ext uri="{FF2B5EF4-FFF2-40B4-BE49-F238E27FC236}">
                  <a16:creationId xmlns:a16="http://schemas.microsoft.com/office/drawing/2014/main" id="{EA390146-F4B6-7F02-A830-FF5E8D0C0BC4}"/>
                </a:ext>
              </a:extLst>
            </p:cNvPr>
            <p:cNvCxnSpPr>
              <a:cxnSpLocks/>
              <a:stCxn id="65" idx="2"/>
              <a:endCxn id="76" idx="0"/>
            </p:cNvCxnSpPr>
            <p:nvPr/>
          </p:nvCxnSpPr>
          <p:spPr>
            <a:xfrm>
              <a:off x="1446866" y="4739181"/>
              <a:ext cx="1407387" cy="89233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矢印コネクタ 72">
              <a:extLst>
                <a:ext uri="{FF2B5EF4-FFF2-40B4-BE49-F238E27FC236}">
                  <a16:creationId xmlns:a16="http://schemas.microsoft.com/office/drawing/2014/main" id="{2C225271-1BBD-0A7A-AF5A-233F9DBF7C03}"/>
                </a:ext>
              </a:extLst>
            </p:cNvPr>
            <p:cNvCxnSpPr>
              <a:cxnSpLocks/>
              <a:stCxn id="66" idx="2"/>
              <a:endCxn id="78" idx="0"/>
            </p:cNvCxnSpPr>
            <p:nvPr/>
          </p:nvCxnSpPr>
          <p:spPr>
            <a:xfrm>
              <a:off x="3057776" y="4744500"/>
              <a:ext cx="0" cy="172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矢印コネクタ 73">
              <a:extLst>
                <a:ext uri="{FF2B5EF4-FFF2-40B4-BE49-F238E27FC236}">
                  <a16:creationId xmlns:a16="http://schemas.microsoft.com/office/drawing/2014/main" id="{B2779E27-81EE-5747-273D-87D767EF368D}"/>
                </a:ext>
              </a:extLst>
            </p:cNvPr>
            <p:cNvCxnSpPr>
              <a:cxnSpLocks/>
              <a:stCxn id="67" idx="2"/>
              <a:endCxn id="77" idx="0"/>
            </p:cNvCxnSpPr>
            <p:nvPr/>
          </p:nvCxnSpPr>
          <p:spPr>
            <a:xfrm>
              <a:off x="1266560" y="5922419"/>
              <a:ext cx="0" cy="2401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矢印コネクタ 74">
              <a:extLst>
                <a:ext uri="{FF2B5EF4-FFF2-40B4-BE49-F238E27FC236}">
                  <a16:creationId xmlns:a16="http://schemas.microsoft.com/office/drawing/2014/main" id="{841FD43E-ACEB-203D-CEAF-35A1C0D67468}"/>
                </a:ext>
              </a:extLst>
            </p:cNvPr>
            <p:cNvCxnSpPr>
              <a:cxnSpLocks/>
              <a:stCxn id="76" idx="2"/>
              <a:endCxn id="68" idx="0"/>
            </p:cNvCxnSpPr>
            <p:nvPr/>
          </p:nvCxnSpPr>
          <p:spPr>
            <a:xfrm flipH="1">
              <a:off x="2854253" y="5939291"/>
              <a:ext cx="1" cy="22329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FCF75862-814B-F530-4662-CA68B7EA0B47}"/>
                </a:ext>
              </a:extLst>
            </p:cNvPr>
            <p:cNvSpPr txBox="1"/>
            <p:nvPr/>
          </p:nvSpPr>
          <p:spPr>
            <a:xfrm>
              <a:off x="2028784" y="5631514"/>
              <a:ext cx="165093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thoracotomy,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6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5DD6C658-2677-B19B-DF9C-DD575BFD80C7}"/>
                </a:ext>
              </a:extLst>
            </p:cNvPr>
            <p:cNvSpPr txBox="1"/>
            <p:nvPr/>
          </p:nvSpPr>
          <p:spPr>
            <a:xfrm>
              <a:off x="616326" y="6162582"/>
              <a:ext cx="1300469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584C4B0F-03AC-B4B8-9C34-FA805645297C}"/>
                </a:ext>
              </a:extLst>
            </p:cNvPr>
            <p:cNvSpPr txBox="1"/>
            <p:nvPr/>
          </p:nvSpPr>
          <p:spPr>
            <a:xfrm>
              <a:off x="2465590" y="4916549"/>
              <a:ext cx="1184372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ath,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0FE14E72-E1ED-7604-5937-D704BAFAF883}"/>
              </a:ext>
            </a:extLst>
          </p:cNvPr>
          <p:cNvCxnSpPr>
            <a:stCxn id="63" idx="2"/>
            <a:endCxn id="6" idx="0"/>
          </p:cNvCxnSpPr>
          <p:nvPr/>
        </p:nvCxnSpPr>
        <p:spPr>
          <a:xfrm flipH="1">
            <a:off x="1805498" y="3220942"/>
            <a:ext cx="4284797" cy="555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>
            <a:extLst>
              <a:ext uri="{FF2B5EF4-FFF2-40B4-BE49-F238E27FC236}">
                <a16:creationId xmlns:a16="http://schemas.microsoft.com/office/drawing/2014/main" id="{4639EDE0-D1E9-4806-FD0E-818D12DCCF3A}"/>
              </a:ext>
            </a:extLst>
          </p:cNvPr>
          <p:cNvCxnSpPr>
            <a:cxnSpLocks/>
            <a:stCxn id="63" idx="2"/>
            <a:endCxn id="29" idx="0"/>
          </p:cNvCxnSpPr>
          <p:nvPr/>
        </p:nvCxnSpPr>
        <p:spPr>
          <a:xfrm flipH="1">
            <a:off x="5160433" y="3220942"/>
            <a:ext cx="929862" cy="5496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矢印コネクタ 80">
            <a:extLst>
              <a:ext uri="{FF2B5EF4-FFF2-40B4-BE49-F238E27FC236}">
                <a16:creationId xmlns:a16="http://schemas.microsoft.com/office/drawing/2014/main" id="{F63A0D67-6D74-CE58-4557-160C845B2563}"/>
              </a:ext>
            </a:extLst>
          </p:cNvPr>
          <p:cNvCxnSpPr>
            <a:cxnSpLocks/>
            <a:stCxn id="63" idx="2"/>
            <a:endCxn id="46" idx="0"/>
          </p:cNvCxnSpPr>
          <p:nvPr/>
        </p:nvCxnSpPr>
        <p:spPr>
          <a:xfrm>
            <a:off x="6090295" y="3220942"/>
            <a:ext cx="2416723" cy="5496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F0C4B47E-CE2E-92D4-5CBC-5C05DCA8994A}"/>
              </a:ext>
            </a:extLst>
          </p:cNvPr>
          <p:cNvCxnSpPr>
            <a:cxnSpLocks/>
            <a:stCxn id="63" idx="2"/>
            <a:endCxn id="22" idx="0"/>
          </p:cNvCxnSpPr>
          <p:nvPr/>
        </p:nvCxnSpPr>
        <p:spPr>
          <a:xfrm>
            <a:off x="6090295" y="3220942"/>
            <a:ext cx="5106839" cy="5572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58314CA3-0FC6-B7EC-E4AF-49A463B2168F}"/>
              </a:ext>
            </a:extLst>
          </p:cNvPr>
          <p:cNvSpPr/>
          <p:nvPr/>
        </p:nvSpPr>
        <p:spPr>
          <a:xfrm>
            <a:off x="180605" y="6587859"/>
            <a:ext cx="12868074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</a:rPr>
              <a:t>Abbreviations, TEVAR: thoracic endovascular aortic repair</a:t>
            </a:r>
            <a:r>
              <a:rPr kumimoji="0" lang="en-US" altLang="ja-JP" sz="1000" b="0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.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521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36</TotalTime>
  <Words>219</Words>
  <Application>Microsoft Office PowerPoint</Application>
  <PresentationFormat>ワイド画面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成哉 石末</dc:creator>
  <cp:lastModifiedBy>ISHIZUE Naruya</cp:lastModifiedBy>
  <cp:revision>11</cp:revision>
  <dcterms:created xsi:type="dcterms:W3CDTF">2023-04-27T09:07:43Z</dcterms:created>
  <dcterms:modified xsi:type="dcterms:W3CDTF">2023-12-11T11:35:31Z</dcterms:modified>
</cp:coreProperties>
</file>